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15"/>
  </p:notesMasterIdLst>
  <p:sldIdLst>
    <p:sldId id="331" r:id="rId2"/>
    <p:sldId id="296" r:id="rId3"/>
    <p:sldId id="340" r:id="rId4"/>
    <p:sldId id="310" r:id="rId5"/>
    <p:sldId id="322" r:id="rId6"/>
    <p:sldId id="338" r:id="rId7"/>
    <p:sldId id="339" r:id="rId8"/>
    <p:sldId id="334" r:id="rId9"/>
    <p:sldId id="333" r:id="rId10"/>
    <p:sldId id="327" r:id="rId11"/>
    <p:sldId id="328" r:id="rId12"/>
    <p:sldId id="329" r:id="rId13"/>
    <p:sldId id="330" r:id="rId1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47" d="100"/>
          <a:sy n="47" d="100"/>
        </p:scale>
        <p:origin x="217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0F5773-49FF-400B-8827-3619D9ABBD49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2993F9-AAB4-4162-BB16-8BE6C480C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431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0107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600" b="1" dirty="0"/>
              <a:t>Edited legen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147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4350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85395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Added table</a:t>
            </a:r>
          </a:p>
          <a:p>
            <a:pPr algn="l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88948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Added tab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50987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Added tab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993F9-AAB4-4162-BB16-8BE6C480CBCB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3141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613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834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897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097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421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80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856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955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367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720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758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7ED4A-02A7-4A6A-8B89-A57F03542D3B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1F6EC-AC72-43BC-8A12-32341557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286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alik.hussain@hsc.wvu.edu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png"/><Relationship Id="rId7" Type="http://schemas.openxmlformats.org/officeDocument/2006/relationships/image" Target="../media/image1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1CB12B2-212B-4D3E-B95B-45D3B8013B6F}"/>
              </a:ext>
            </a:extLst>
          </p:cNvPr>
          <p:cNvSpPr txBox="1"/>
          <p:nvPr/>
        </p:nvSpPr>
        <p:spPr>
          <a:xfrm>
            <a:off x="532263" y="300251"/>
            <a:ext cx="5800298" cy="7675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Data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xidant-induced epithelial alarmin pathway mediates lung inflammation and functional decline following ultrafine carbon and ozone inhalation co-exposure</a:t>
            </a:r>
            <a:endParaRPr lang="en-US" sz="14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irrita Majumder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lliam T. Goldsmith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Vamsi K. Kodali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,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urugesan Velayutham 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herri A. Friend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,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, Valery  V.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hramtsov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 Timothy R. Nurkiewicz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aron Erdely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,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Patti C. </a:t>
            </a:r>
            <a:r>
              <a:rPr lang="en-GB" sz="1400" dirty="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Zeidler</a:t>
            </a:r>
            <a:r>
              <a:rPr lang="en-GB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-Erdely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,c</a:t>
            </a:r>
            <a:r>
              <a:rPr lang="en-GB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nce Castranova 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Jack R. Harkema 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Eric E Kelley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alik Hussain 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GB" sz="1400" baseline="300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GB" sz="1400" b="1" baseline="300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Physiology and Pharmacology, School of Medicine, West Virginia University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nter for Inhalation Toxicology (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TOX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School of Medicine, West Virginia University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GB" sz="1400" baseline="300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c</a:t>
            </a:r>
            <a:r>
              <a:rPr lang="en-GB" sz="1400" b="1" baseline="300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tional Institute for Occupational Safety and Health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GB" sz="1400" baseline="300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d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chemistry, School of Medicine, West Virginia University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partment of Pathobiology and Diagnostic Investigation, School of Veterinary Medicine, Michigan State University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lik Hussain DVM, PhD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chool of Medicine, West Virginia University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epartment of Physiology and Pharmacology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obert C. Byrd Health Sciences Center HSC-N 3039, 3074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4 Medical Center Drive, Morgantown, WV 26506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hlinkClick r:id="rId2"/>
              </a:rPr>
              <a:t>salik.hussain@hsc.wvu.edu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hone Office: (304) 293-8047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  <a:tabLst>
                <a:tab pos="603250" algn="l"/>
              </a:tabLst>
            </a:pPr>
            <a:r>
              <a:rPr lang="en-US" sz="2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43423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C33E8F8-4E95-434B-B6D4-DA2B325B9A29}"/>
              </a:ext>
            </a:extLst>
          </p:cNvPr>
          <p:cNvSpPr txBox="1"/>
          <p:nvPr/>
        </p:nvSpPr>
        <p:spPr>
          <a:xfrm>
            <a:off x="547326" y="1385356"/>
            <a:ext cx="53617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2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mer sequences for real-time PC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3D66B36-D40A-4B67-81B4-CD8B1264BD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310" y="1801504"/>
            <a:ext cx="5967484" cy="5037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558454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C33E8F8-4E95-434B-B6D4-DA2B325B9A29}"/>
              </a:ext>
            </a:extLst>
          </p:cNvPr>
          <p:cNvSpPr txBox="1"/>
          <p:nvPr/>
        </p:nvSpPr>
        <p:spPr>
          <a:xfrm>
            <a:off x="348018" y="1109310"/>
            <a:ext cx="60527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3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aw data used to create heat map presented in Figure 2F</a:t>
            </a:r>
            <a:endParaRPr lang="en-US" sz="14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7569575"/>
              </p:ext>
            </p:extLst>
          </p:nvPr>
        </p:nvGraphicFramePr>
        <p:xfrm>
          <a:off x="416896" y="2346118"/>
          <a:ext cx="6192909" cy="4812329"/>
        </p:xfrm>
        <a:graphic>
          <a:graphicData uri="http://schemas.openxmlformats.org/drawingml/2006/table">
            <a:tbl>
              <a:tblPr firstRow="1" firstCol="1" bandRow="1"/>
              <a:tblGrid>
                <a:gridCol w="1281634">
                  <a:extLst>
                    <a:ext uri="{9D8B030D-6E8A-4147-A177-3AD203B41FA5}">
                      <a16:colId xmlns:a16="http://schemas.microsoft.com/office/drawing/2014/main" val="1194963537"/>
                    </a:ext>
                  </a:extLst>
                </a:gridCol>
                <a:gridCol w="1239245">
                  <a:extLst>
                    <a:ext uri="{9D8B030D-6E8A-4147-A177-3AD203B41FA5}">
                      <a16:colId xmlns:a16="http://schemas.microsoft.com/office/drawing/2014/main" val="626007830"/>
                    </a:ext>
                  </a:extLst>
                </a:gridCol>
                <a:gridCol w="1261101">
                  <a:extLst>
                    <a:ext uri="{9D8B030D-6E8A-4147-A177-3AD203B41FA5}">
                      <a16:colId xmlns:a16="http://schemas.microsoft.com/office/drawing/2014/main" val="2068274075"/>
                    </a:ext>
                  </a:extLst>
                </a:gridCol>
                <a:gridCol w="1265738">
                  <a:extLst>
                    <a:ext uri="{9D8B030D-6E8A-4147-A177-3AD203B41FA5}">
                      <a16:colId xmlns:a16="http://schemas.microsoft.com/office/drawing/2014/main" val="1551976133"/>
                    </a:ext>
                  </a:extLst>
                </a:gridCol>
                <a:gridCol w="1145191">
                  <a:extLst>
                    <a:ext uri="{9D8B030D-6E8A-4147-A177-3AD203B41FA5}">
                      <a16:colId xmlns:a16="http://schemas.microsoft.com/office/drawing/2014/main" val="701893584"/>
                    </a:ext>
                  </a:extLst>
                </a:gridCol>
              </a:tblGrid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6420265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91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410 ± .63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711 ± .51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.412 ± .93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 6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8293366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18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88±.61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653±.50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113±.34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C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3683503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76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990±1.31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004±.56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.157 ± .99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 33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9182021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74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39 ± 1.32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884 ± .910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455±.61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1β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0691003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76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97 ± .68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050 ± .53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53±.40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ungkine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2174973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55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30±.57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34±.26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426±.39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phiiR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633385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20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20 ± .22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186 ± .42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85 ± .43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xcl10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0541870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42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12±.80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753±.53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693±.45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MOX1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661921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41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566±.663 (n=7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314±1.26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2.009±.553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SLP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7477343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41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62±.62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167 ± 1.01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039±.29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xo4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4350293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86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32±.94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658±.76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956±.30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3ra2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929974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4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49±.60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.067±.24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.240±1.154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3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3797925"/>
                  </a:ext>
                </a:extLst>
              </a:tr>
              <a:tr h="4010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68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967±1.56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108 ± 1.06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196 ± .49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ak2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3511257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81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06±.56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03±.37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107±.37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t6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0813239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30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20±.62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186±.89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85± .67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uc5b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15956"/>
                  </a:ext>
                </a:extLst>
              </a:tr>
              <a:tr h="2005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75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48± .72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68±.85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160±.91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FN-B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68091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8506291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C33E8F8-4E95-434B-B6D4-DA2B325B9A29}"/>
              </a:ext>
            </a:extLst>
          </p:cNvPr>
          <p:cNvSpPr txBox="1"/>
          <p:nvPr/>
        </p:nvSpPr>
        <p:spPr>
          <a:xfrm>
            <a:off x="348018" y="1109310"/>
            <a:ext cx="60527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4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aw data used to create heat map presented in Figure 4G</a:t>
            </a:r>
            <a:endParaRPr lang="en-US" sz="1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053681"/>
              </p:ext>
            </p:extLst>
          </p:nvPr>
        </p:nvGraphicFramePr>
        <p:xfrm>
          <a:off x="610477" y="1864244"/>
          <a:ext cx="5960141" cy="6772756"/>
        </p:xfrm>
        <a:graphic>
          <a:graphicData uri="http://schemas.openxmlformats.org/drawingml/2006/table">
            <a:tbl>
              <a:tblPr firstRow="1" firstCol="1" bandRow="1"/>
              <a:tblGrid>
                <a:gridCol w="711392">
                  <a:extLst>
                    <a:ext uri="{9D8B030D-6E8A-4147-A177-3AD203B41FA5}">
                      <a16:colId xmlns:a16="http://schemas.microsoft.com/office/drawing/2014/main" val="4225256323"/>
                    </a:ext>
                  </a:extLst>
                </a:gridCol>
                <a:gridCol w="990595">
                  <a:extLst>
                    <a:ext uri="{9D8B030D-6E8A-4147-A177-3AD203B41FA5}">
                      <a16:colId xmlns:a16="http://schemas.microsoft.com/office/drawing/2014/main" val="697071865"/>
                    </a:ext>
                  </a:extLst>
                </a:gridCol>
                <a:gridCol w="933861">
                  <a:extLst>
                    <a:ext uri="{9D8B030D-6E8A-4147-A177-3AD203B41FA5}">
                      <a16:colId xmlns:a16="http://schemas.microsoft.com/office/drawing/2014/main" val="3747408375"/>
                    </a:ext>
                  </a:extLst>
                </a:gridCol>
                <a:gridCol w="611950">
                  <a:extLst>
                    <a:ext uri="{9D8B030D-6E8A-4147-A177-3AD203B41FA5}">
                      <a16:colId xmlns:a16="http://schemas.microsoft.com/office/drawing/2014/main" val="2740203047"/>
                    </a:ext>
                  </a:extLst>
                </a:gridCol>
                <a:gridCol w="916013">
                  <a:extLst>
                    <a:ext uri="{9D8B030D-6E8A-4147-A177-3AD203B41FA5}">
                      <a16:colId xmlns:a16="http://schemas.microsoft.com/office/drawing/2014/main" val="2479861018"/>
                    </a:ext>
                  </a:extLst>
                </a:gridCol>
                <a:gridCol w="1013543">
                  <a:extLst>
                    <a:ext uri="{9D8B030D-6E8A-4147-A177-3AD203B41FA5}">
                      <a16:colId xmlns:a16="http://schemas.microsoft.com/office/drawing/2014/main" val="1210720304"/>
                    </a:ext>
                  </a:extLst>
                </a:gridCol>
                <a:gridCol w="782787">
                  <a:extLst>
                    <a:ext uri="{9D8B030D-6E8A-4147-A177-3AD203B41FA5}">
                      <a16:colId xmlns:a16="http://schemas.microsoft.com/office/drawing/2014/main" val="28140740"/>
                    </a:ext>
                  </a:extLst>
                </a:gridCol>
              </a:tblGrid>
              <a:tr h="33329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+EUK-13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/Vehicl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3+EUK-13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3/Vehicl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806777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838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38 ± 1.05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05 ± .850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.142 ± .0.861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.267 ± 0.659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259 ± 1.333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9791086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2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46 ± 0.788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50 ± 1.405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650 ± 0.206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812 ± 0.201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246 ± 0.916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C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6283624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415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31 ± .539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49 ± 1.059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676 ± 1.121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.277 ± .654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.227 ± 1.375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SLP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6955544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42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81 ± .723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34 ± 1.222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.067 ± 0.243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324 ± .939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196 ± 0.473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13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9532840"/>
                  </a:ext>
                </a:extLst>
              </a:tr>
              <a:tr h="33329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784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358 ± .742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91 ± 1.511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042 ± .6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50 ± 0.298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793 ± 0.873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NF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8864258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74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462 ± .603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54 ± 1.214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880 ± .706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949 ± .759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258 ± 1.332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1β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2405702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0.949 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79 ± 0.65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722± 1.497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618 ± 0.884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91 ± 1.156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793 ± 0.520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FN-B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8492767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0.529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37 ± 1.288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42 ± 1.629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042 ± 0.426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25 ± 0.892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362 ± 0.545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ak 1 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7561431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1.68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857 ± 1.058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61 ± 0.263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196 ± .494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18 ± 1.248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.519 ± 0.629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ak 2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0767092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28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73 ± 1.1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55 ± 0.902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449 ± .836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55 ± 1.391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938 ± 0.867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uc5ac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5190084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.308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691 ± .835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04 ± 0.623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85 ± .673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 ± 1.004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234 ± 1.028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uc 5b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8085260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1.022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89 ± 1.291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16 ± 0.203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077 ± 0.602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949 ± 0.539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974 ± 0.854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rg 1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9962699"/>
                  </a:ext>
                </a:extLst>
              </a:tr>
              <a:tr h="49993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0.957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95 ± 0.829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13 ± 1.038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16 ± 0.615 (n=5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25 ± 1.133 (n=6)</a:t>
                      </a: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 ± 0.985 (n=5)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phii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5456" marR="5545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60449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29421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C33E8F8-4E95-434B-B6D4-DA2B325B9A29}"/>
              </a:ext>
            </a:extLst>
          </p:cNvPr>
          <p:cNvSpPr txBox="1"/>
          <p:nvPr/>
        </p:nvSpPr>
        <p:spPr>
          <a:xfrm>
            <a:off x="348018" y="1109310"/>
            <a:ext cx="60527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5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aw data used to create heat map presented in Figure 5D</a:t>
            </a:r>
            <a:endParaRPr lang="en-US" sz="14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8617993"/>
              </p:ext>
            </p:extLst>
          </p:nvPr>
        </p:nvGraphicFramePr>
        <p:xfrm>
          <a:off x="485776" y="2170231"/>
          <a:ext cx="6163217" cy="5419288"/>
        </p:xfrm>
        <a:graphic>
          <a:graphicData uri="http://schemas.openxmlformats.org/drawingml/2006/table">
            <a:tbl>
              <a:tblPr firstRow="1" firstCol="1" bandRow="1"/>
              <a:tblGrid>
                <a:gridCol w="1078398">
                  <a:extLst>
                    <a:ext uri="{9D8B030D-6E8A-4147-A177-3AD203B41FA5}">
                      <a16:colId xmlns:a16="http://schemas.microsoft.com/office/drawing/2014/main" val="746287884"/>
                    </a:ext>
                  </a:extLst>
                </a:gridCol>
                <a:gridCol w="994684">
                  <a:extLst>
                    <a:ext uri="{9D8B030D-6E8A-4147-A177-3AD203B41FA5}">
                      <a16:colId xmlns:a16="http://schemas.microsoft.com/office/drawing/2014/main" val="4003146483"/>
                    </a:ext>
                  </a:extLst>
                </a:gridCol>
                <a:gridCol w="1010504">
                  <a:extLst>
                    <a:ext uri="{9D8B030D-6E8A-4147-A177-3AD203B41FA5}">
                      <a16:colId xmlns:a16="http://schemas.microsoft.com/office/drawing/2014/main" val="2457354168"/>
                    </a:ext>
                  </a:extLst>
                </a:gridCol>
                <a:gridCol w="876034">
                  <a:extLst>
                    <a:ext uri="{9D8B030D-6E8A-4147-A177-3AD203B41FA5}">
                      <a16:colId xmlns:a16="http://schemas.microsoft.com/office/drawing/2014/main" val="3004530421"/>
                    </a:ext>
                  </a:extLst>
                </a:gridCol>
                <a:gridCol w="1251100">
                  <a:extLst>
                    <a:ext uri="{9D8B030D-6E8A-4147-A177-3AD203B41FA5}">
                      <a16:colId xmlns:a16="http://schemas.microsoft.com/office/drawing/2014/main" val="693000307"/>
                    </a:ext>
                  </a:extLst>
                </a:gridCol>
                <a:gridCol w="952497">
                  <a:extLst>
                    <a:ext uri="{9D8B030D-6E8A-4147-A177-3AD203B41FA5}">
                      <a16:colId xmlns:a16="http://schemas.microsoft.com/office/drawing/2014/main" val="467058282"/>
                    </a:ext>
                  </a:extLst>
                </a:gridCol>
              </a:tblGrid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/Iso ab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/TSLP nAb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900" b="1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Iso ab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900" b="1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TSLP nAb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6735403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99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53 ± 1.16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739 ± 1.01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054±.34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757±1.49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 6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689944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 1.0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727 ± 1.26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05 ± 0.96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846 ± 0.78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77 ± 1.64 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C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1249575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 0.56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12 ± 0.6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53 ± 1.01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139 ± 0.59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409 ± 1.27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SLP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903405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27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22 ± 0.671 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12 ± 1.15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897 ±.56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873 ±.80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3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4963894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 0.90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845 ± 0.61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16 ± 0.14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527 ± .0.26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443 ± 1.52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NF-α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9221551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 0.7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47  ± 0.39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92 ± 0.87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847 ± 0.66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932 ± 0.90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1β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9241802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 .52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93 ± 0.85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29 ± 0.80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674±.66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897±.651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FN-B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3715246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56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75 ± 0.78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08 ± 0.54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384±.48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99±1.16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ak1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8360399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748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4 ± 1.0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97 ± 0.81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.176±.83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808±1.19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ak2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6723805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.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17 ± 0.73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31 ± 0.379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381 ± .69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74 ± .893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uc5ac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3107729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38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18 ± 0.76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53 ± 1.10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310±.83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866±.726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uc5b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3520384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±1.004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92 ± 1.05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54 ± 1.0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234±.92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51 ± 1.005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rg1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7819032"/>
                  </a:ext>
                </a:extLst>
              </a:tr>
              <a:tr h="38709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± 1.2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01 ± 1.047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45 ± 1.041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937 ± .520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763 ± .528 (n=5)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phiR</a:t>
                      </a:r>
                    </a:p>
                  </a:txBody>
                  <a:tcPr marL="68323" marR="6832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10343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73540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F9DC8B7-DBE9-4681-9AD8-EFA3A31D7A82}"/>
              </a:ext>
            </a:extLst>
          </p:cNvPr>
          <p:cNvSpPr txBox="1"/>
          <p:nvPr/>
        </p:nvSpPr>
        <p:spPr>
          <a:xfrm>
            <a:off x="429952" y="5178552"/>
            <a:ext cx="59708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S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Schematic diagram for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-viv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o-exposure system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BD95FE1-06FC-44F1-B406-56CBB8BE2B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749" y="568056"/>
            <a:ext cx="5968501" cy="4432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189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FEB5D65-C3FE-409D-8CC5-0F911B3D661D}"/>
              </a:ext>
            </a:extLst>
          </p:cNvPr>
          <p:cNvGrpSpPr/>
          <p:nvPr/>
        </p:nvGrpSpPr>
        <p:grpSpPr>
          <a:xfrm>
            <a:off x="482924" y="832489"/>
            <a:ext cx="5892151" cy="4306599"/>
            <a:chOff x="652863" y="4612918"/>
            <a:chExt cx="5892151" cy="430659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49852A4-F81A-4104-B956-1EC564CD5E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62718" y="5063958"/>
              <a:ext cx="5281952" cy="1193149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5FD3C44-ABB0-4142-8759-5A4A11E9E647}"/>
                </a:ext>
              </a:extLst>
            </p:cNvPr>
            <p:cNvSpPr txBox="1"/>
            <p:nvPr/>
          </p:nvSpPr>
          <p:spPr>
            <a:xfrm>
              <a:off x="862772" y="4643315"/>
              <a:ext cx="10807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hematic 1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AE08EEC-E82F-4C06-B3BD-6A754CCBA03B}"/>
                </a:ext>
              </a:extLst>
            </p:cNvPr>
            <p:cNvSpPr txBox="1"/>
            <p:nvPr/>
          </p:nvSpPr>
          <p:spPr>
            <a:xfrm>
              <a:off x="870137" y="6400751"/>
              <a:ext cx="10807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hematic 2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E3D4F9EC-3CEC-4EB5-831D-BB4046DE8895}"/>
                </a:ext>
              </a:extLst>
            </p:cNvPr>
            <p:cNvSpPr/>
            <p:nvPr/>
          </p:nvSpPr>
          <p:spPr>
            <a:xfrm>
              <a:off x="652863" y="4612918"/>
              <a:ext cx="1515291" cy="3377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C4569455-8397-413D-8C8C-370E0387FC30}"/>
                </a:ext>
              </a:extLst>
            </p:cNvPr>
            <p:cNvSpPr/>
            <p:nvPr/>
          </p:nvSpPr>
          <p:spPr>
            <a:xfrm>
              <a:off x="652863" y="6360236"/>
              <a:ext cx="1515291" cy="3377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9256BD7-C520-438E-9A9D-4FA218D543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2374" y="6801157"/>
              <a:ext cx="5882640" cy="2118360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017B576-AF0E-4098-8E7B-E0F25DB9D0AE}"/>
              </a:ext>
            </a:extLst>
          </p:cNvPr>
          <p:cNvSpPr txBox="1"/>
          <p:nvPr/>
        </p:nvSpPr>
        <p:spPr>
          <a:xfrm>
            <a:off x="443575" y="5242217"/>
            <a:ext cx="59708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S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Schematic diagram for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experimental group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58454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7928157-1BBF-4593-B75E-1A1001A3C79D}"/>
              </a:ext>
            </a:extLst>
          </p:cNvPr>
          <p:cNvSpPr txBox="1"/>
          <p:nvPr/>
        </p:nvSpPr>
        <p:spPr>
          <a:xfrm>
            <a:off x="395511" y="4434499"/>
            <a:ext cx="606697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S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Co-exposure induces higher inflammatory protein expression compared to individual exposures. Concentration of IL6, KC, IL-1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TNF-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TSLP and IL-13 in bronchoalveolar lavage of mice treated with Air, CB(10m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O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2 ppm), or CB+O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10m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 2ppm) for 3 hours and euthanized 24 hours later.  n=5-6 per group ; * p &lt; 0.05, ** p &lt; 0.01 and *** p &lt; 0.001. Two-way ANOVA followed by post-hoc Tukey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9A3243C-D018-405D-973C-F308021482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1880" y="1821180"/>
            <a:ext cx="4226560" cy="2443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69839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439ABDD-DE6F-4A16-A3A2-27F08B4DEBF7}"/>
              </a:ext>
            </a:extLst>
          </p:cNvPr>
          <p:cNvSpPr txBox="1"/>
          <p:nvPr/>
        </p:nvSpPr>
        <p:spPr>
          <a:xfrm>
            <a:off x="184407" y="5234384"/>
            <a:ext cx="606697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S4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Large airway Newtonian resistance (Rn) measurements after inhalation co-exposures.  Mice were  exposed to  Air, CB(10m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O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2 ppm), or CB+O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10m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 2ppm) for 3 hours and euthanized 24 hours later.  n=5-6 per grou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36E77B2-A100-452B-AACA-B3A770BD3B3F}"/>
              </a:ext>
            </a:extLst>
          </p:cNvPr>
          <p:cNvSpPr txBox="1"/>
          <p:nvPr/>
        </p:nvSpPr>
        <p:spPr>
          <a:xfrm>
            <a:off x="471246" y="2343249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C35C11B-58A3-4DDA-86F2-F9AC143CEA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168" y="2343249"/>
            <a:ext cx="3204793" cy="2346817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397A6EF1-34AE-47DC-9AE5-13C5C60CA0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7728" y="2015351"/>
            <a:ext cx="1013460" cy="1394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8406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236550" y="317771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64692"/>
          <a:stretch/>
        </p:blipFill>
        <p:spPr>
          <a:xfrm>
            <a:off x="2994890" y="827300"/>
            <a:ext cx="1033760" cy="133984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4011326" y="317771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61244" y="3198739"/>
            <a:ext cx="2773680" cy="278892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3690595" y="3195505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236550" y="6260730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DB3FAF-A49C-4EFA-86F9-484C312A5783}"/>
              </a:ext>
            </a:extLst>
          </p:cNvPr>
          <p:cNvSpPr txBox="1"/>
          <p:nvPr/>
        </p:nvSpPr>
        <p:spPr>
          <a:xfrm>
            <a:off x="323595" y="8021677"/>
            <a:ext cx="623268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S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 Impact of EUK-134 on A) BAL Total protein B) LDH C) Broncho-alveolar lavage analyses total cells, macrophages and neutrophils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ung tissue real-time PCR mRNA expressio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ELISA without  or with 10mg/kg EUK-134 pretreatment; * p &lt; 0.05, ** p &lt; 0.01 and *** p &lt; 0.001. Two-way ANOVA followed by post-hoc Tukey. 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6537B57F-214B-4D0E-9D26-9CD75AAAE48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5102" r="37671"/>
          <a:stretch/>
        </p:blipFill>
        <p:spPr>
          <a:xfrm>
            <a:off x="323595" y="695510"/>
            <a:ext cx="2781785" cy="2115136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DF18B644-B0B8-4E8E-B255-0683FBE27E3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606" t="17135" r="44297" b="4291"/>
          <a:stretch/>
        </p:blipFill>
        <p:spPr>
          <a:xfrm>
            <a:off x="4162401" y="743724"/>
            <a:ext cx="2481555" cy="199975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6ADB7C6-2970-4051-805A-991D5B50756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8763"/>
          <a:stretch/>
        </p:blipFill>
        <p:spPr>
          <a:xfrm>
            <a:off x="651730" y="5932521"/>
            <a:ext cx="4169190" cy="206789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23EA9C09-AC7D-4818-A22F-D9DAD91F5D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33950" y="5981735"/>
            <a:ext cx="1207550" cy="15538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7625" y="3455419"/>
            <a:ext cx="3302970" cy="205503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236550" y="3380171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4915993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105014" y="427532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00FC6DA-74FA-47C8-81BF-5CD7242FBD95}"/>
              </a:ext>
            </a:extLst>
          </p:cNvPr>
          <p:cNvSpPr txBox="1"/>
          <p:nvPr/>
        </p:nvSpPr>
        <p:spPr>
          <a:xfrm>
            <a:off x="3624511" y="506289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BDB3FAF-A49C-4EFA-86F9-484C312A5783}"/>
              </a:ext>
            </a:extLst>
          </p:cNvPr>
          <p:cNvSpPr txBox="1"/>
          <p:nvPr/>
        </p:nvSpPr>
        <p:spPr>
          <a:xfrm>
            <a:off x="395511" y="5470454"/>
            <a:ext cx="6066978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S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 Impact of EUK-134 o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large airway Newtonian resistance (Rn),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EV 0.1,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Total respiratory resistance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Rr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fter co-exposure with or without EUK-134. N=4-6 per group ; * p &lt; 0.05, ** p &lt; 0.01 and *** p &lt; 0.001. Two-way ANOVA followed by post-hoc Tukey. . ɛ  denotes different between exposures at the same dose of methacholine. </a:t>
            </a: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00FC6DA-74FA-47C8-81BF-5CD7242FBD95}"/>
              </a:ext>
            </a:extLst>
          </p:cNvPr>
          <p:cNvSpPr txBox="1"/>
          <p:nvPr/>
        </p:nvSpPr>
        <p:spPr>
          <a:xfrm>
            <a:off x="1548492" y="3081655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024A6920-D12C-460E-830D-6908FDFBA46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139" r="31732"/>
          <a:stretch/>
        </p:blipFill>
        <p:spPr>
          <a:xfrm>
            <a:off x="3439519" y="885117"/>
            <a:ext cx="3198669" cy="232374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518825C-1C36-4FE9-BDDC-A6591C91206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3421" r="33537"/>
          <a:stretch/>
        </p:blipFill>
        <p:spPr>
          <a:xfrm>
            <a:off x="214975" y="885117"/>
            <a:ext cx="3203507" cy="229639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E66D5E7-3B15-439D-9816-17551C2D54D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2414" r="33698"/>
          <a:stretch/>
        </p:blipFill>
        <p:spPr>
          <a:xfrm>
            <a:off x="2008218" y="3218362"/>
            <a:ext cx="2862602" cy="212237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1613" y="796864"/>
            <a:ext cx="1213758" cy="1203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85123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BDB3FAF-A49C-4EFA-86F9-484C312A5783}"/>
              </a:ext>
            </a:extLst>
          </p:cNvPr>
          <p:cNvSpPr txBox="1"/>
          <p:nvPr/>
        </p:nvSpPr>
        <p:spPr>
          <a:xfrm>
            <a:off x="240696" y="4066168"/>
            <a:ext cx="637326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S7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 Impact of TSLP neutralization  o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DH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L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LISA with TSLP isotype and neutralizing antibody in air and co-exposure group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Newtonian resistance (Rn) after co-exposure with TSLP isotype and neutralizing antibody. N=5-6 per group ; * p &lt; 0.05, ** p &lt; 0.01 and *** p &lt; 0.001. Two-way ANOVA followed by post-hoc Tukey. * p&lt;0.05, * p&lt;0.01, *** p&lt;0.001, **** p&lt;0.0001. ɛ  denotes significant difference between isotype and neutralizing antibody in co-exposure group at the same dose of methacholine </a:t>
            </a:r>
          </a:p>
          <a:p>
            <a:pPr algn="just"/>
            <a:endParaRPr 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98538" y="163862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3427327" y="159068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9CB6C49-1C03-464F-9CC2-2CCD932E33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1962"/>
          <a:stretch/>
        </p:blipFill>
        <p:spPr>
          <a:xfrm>
            <a:off x="487065" y="159068"/>
            <a:ext cx="2008485" cy="170248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3B088F4-B302-45BF-B7C2-68CA056A26F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5811" r="35794"/>
          <a:stretch/>
        </p:blipFill>
        <p:spPr>
          <a:xfrm>
            <a:off x="3826544" y="282615"/>
            <a:ext cx="2529462" cy="1658345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DD4809E-79C7-4323-8E63-0E4539CADB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81927" y="573943"/>
            <a:ext cx="1158240" cy="92202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9198F760-47DE-4ED8-8BDB-7EA0A53299F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3834" r="33310" b="12632"/>
          <a:stretch/>
        </p:blipFill>
        <p:spPr>
          <a:xfrm>
            <a:off x="2172157" y="2089290"/>
            <a:ext cx="2812490" cy="171127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C0B8153-70DF-4727-A53D-D95251A4FB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61047" y="2014870"/>
            <a:ext cx="1068737" cy="75731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C932332-EB7C-4F67-92B0-7B360EE8AA2B}"/>
              </a:ext>
            </a:extLst>
          </p:cNvPr>
          <p:cNvSpPr txBox="1"/>
          <p:nvPr/>
        </p:nvSpPr>
        <p:spPr>
          <a:xfrm>
            <a:off x="1870007" y="2085546"/>
            <a:ext cx="302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20680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FEFDAD7-DB7D-47A9-92EE-79C3DB239255}"/>
              </a:ext>
            </a:extLst>
          </p:cNvPr>
          <p:cNvSpPr txBox="1"/>
          <p:nvPr/>
        </p:nvSpPr>
        <p:spPr>
          <a:xfrm>
            <a:off x="533176" y="352472"/>
            <a:ext cx="5853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Table S1. Animal cohorts for different studies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5C1A92E-86BB-49DA-9CFA-3BF4BA61A3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6705021"/>
              </p:ext>
            </p:extLst>
          </p:nvPr>
        </p:nvGraphicFramePr>
        <p:xfrm>
          <a:off x="215536" y="877240"/>
          <a:ext cx="6426927" cy="3500845"/>
        </p:xfrm>
        <a:graphic>
          <a:graphicData uri="http://schemas.openxmlformats.org/drawingml/2006/table">
            <a:tbl>
              <a:tblPr firstRow="1" firstCol="1" bandRow="1"/>
              <a:tblGrid>
                <a:gridCol w="540321">
                  <a:extLst>
                    <a:ext uri="{9D8B030D-6E8A-4147-A177-3AD203B41FA5}">
                      <a16:colId xmlns:a16="http://schemas.microsoft.com/office/drawing/2014/main" val="540097881"/>
                    </a:ext>
                  </a:extLst>
                </a:gridCol>
                <a:gridCol w="361874">
                  <a:extLst>
                    <a:ext uri="{9D8B030D-6E8A-4147-A177-3AD203B41FA5}">
                      <a16:colId xmlns:a16="http://schemas.microsoft.com/office/drawing/2014/main" val="613100072"/>
                    </a:ext>
                  </a:extLst>
                </a:gridCol>
                <a:gridCol w="521612">
                  <a:extLst>
                    <a:ext uri="{9D8B030D-6E8A-4147-A177-3AD203B41FA5}">
                      <a16:colId xmlns:a16="http://schemas.microsoft.com/office/drawing/2014/main" val="3425755091"/>
                    </a:ext>
                  </a:extLst>
                </a:gridCol>
                <a:gridCol w="521612">
                  <a:extLst>
                    <a:ext uri="{9D8B030D-6E8A-4147-A177-3AD203B41FA5}">
                      <a16:colId xmlns:a16="http://schemas.microsoft.com/office/drawing/2014/main" val="2189472392"/>
                    </a:ext>
                  </a:extLst>
                </a:gridCol>
                <a:gridCol w="494080">
                  <a:extLst>
                    <a:ext uri="{9D8B030D-6E8A-4147-A177-3AD203B41FA5}">
                      <a16:colId xmlns:a16="http://schemas.microsoft.com/office/drawing/2014/main" val="1196076807"/>
                    </a:ext>
                  </a:extLst>
                </a:gridCol>
                <a:gridCol w="497018">
                  <a:extLst>
                    <a:ext uri="{9D8B030D-6E8A-4147-A177-3AD203B41FA5}">
                      <a16:colId xmlns:a16="http://schemas.microsoft.com/office/drawing/2014/main" val="2941429602"/>
                    </a:ext>
                  </a:extLst>
                </a:gridCol>
                <a:gridCol w="490202">
                  <a:extLst>
                    <a:ext uri="{9D8B030D-6E8A-4147-A177-3AD203B41FA5}">
                      <a16:colId xmlns:a16="http://schemas.microsoft.com/office/drawing/2014/main" val="3130720828"/>
                    </a:ext>
                  </a:extLst>
                </a:gridCol>
                <a:gridCol w="479084">
                  <a:extLst>
                    <a:ext uri="{9D8B030D-6E8A-4147-A177-3AD203B41FA5}">
                      <a16:colId xmlns:a16="http://schemas.microsoft.com/office/drawing/2014/main" val="677666791"/>
                    </a:ext>
                  </a:extLst>
                </a:gridCol>
                <a:gridCol w="478144">
                  <a:extLst>
                    <a:ext uri="{9D8B030D-6E8A-4147-A177-3AD203B41FA5}">
                      <a16:colId xmlns:a16="http://schemas.microsoft.com/office/drawing/2014/main" val="1242882851"/>
                    </a:ext>
                  </a:extLst>
                </a:gridCol>
                <a:gridCol w="478144">
                  <a:extLst>
                    <a:ext uri="{9D8B030D-6E8A-4147-A177-3AD203B41FA5}">
                      <a16:colId xmlns:a16="http://schemas.microsoft.com/office/drawing/2014/main" val="2457026457"/>
                    </a:ext>
                  </a:extLst>
                </a:gridCol>
                <a:gridCol w="521612">
                  <a:extLst>
                    <a:ext uri="{9D8B030D-6E8A-4147-A177-3AD203B41FA5}">
                      <a16:colId xmlns:a16="http://schemas.microsoft.com/office/drawing/2014/main" val="3037006091"/>
                    </a:ext>
                  </a:extLst>
                </a:gridCol>
                <a:gridCol w="521612">
                  <a:extLst>
                    <a:ext uri="{9D8B030D-6E8A-4147-A177-3AD203B41FA5}">
                      <a16:colId xmlns:a16="http://schemas.microsoft.com/office/drawing/2014/main" val="416677133"/>
                    </a:ext>
                  </a:extLst>
                </a:gridCol>
                <a:gridCol w="521612">
                  <a:extLst>
                    <a:ext uri="{9D8B030D-6E8A-4147-A177-3AD203B41FA5}">
                      <a16:colId xmlns:a16="http://schemas.microsoft.com/office/drawing/2014/main" val="1397494090"/>
                    </a:ext>
                  </a:extLst>
                </a:gridCol>
              </a:tblGrid>
              <a:tr h="21195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vage and PC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exivent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4226143"/>
                  </a:ext>
                </a:extLst>
              </a:tr>
              <a:tr h="309812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2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0801783"/>
                  </a:ext>
                </a:extLst>
              </a:tr>
              <a:tr h="441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4542421"/>
                  </a:ext>
                </a:extLst>
              </a:tr>
              <a:tr h="29352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6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6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6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6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6123509"/>
                  </a:ext>
                </a:extLst>
              </a:tr>
              <a:tr h="627592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4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+EUK-134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EUK-134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/</a:t>
                      </a:r>
                      <a:r>
                        <a:rPr lang="en-US" sz="8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eh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800" b="1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800" b="1" baseline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eh</a:t>
                      </a:r>
                      <a:endParaRPr lang="en-US" sz="800" b="1" baseline="-25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+EUK-134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EUK-134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ir/</a:t>
                      </a:r>
                      <a:r>
                        <a:rPr lang="en-US" sz="8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eh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800" b="1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800" b="1" baseline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eh</a:t>
                      </a:r>
                      <a:endParaRPr lang="en-US" sz="800" b="1" baseline="-25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1231761"/>
                  </a:ext>
                </a:extLst>
              </a:tr>
              <a:tr h="34259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6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6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4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1187918"/>
                  </a:ext>
                </a:extLst>
              </a:tr>
              <a:tr h="786478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 + TSLP-iso A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 +    TSLP-n A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+ TSLP-I</a:t>
                      </a:r>
                      <a:r>
                        <a:rPr lang="en-US" sz="800" b="1" i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 TSLP n Ab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 +    TSLP-Iso A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ir +  TSLP-n Ab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+ TSLP-</a:t>
                      </a:r>
                      <a:r>
                        <a:rPr lang="en-US" sz="8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so</a:t>
                      </a: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b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+O</a:t>
                      </a:r>
                      <a:r>
                        <a:rPr lang="en-US" sz="8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       TSLP-n Ab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7998500"/>
                  </a:ext>
                </a:extLst>
              </a:tr>
              <a:tr h="4873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77458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4470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0</TotalTime>
  <Words>2757</Words>
  <Application>Microsoft Office PowerPoint</Application>
  <PresentationFormat>Letter Paper (8.5x11 in)</PresentationFormat>
  <Paragraphs>407</Paragraphs>
  <Slides>13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rrita Majumder</dc:creator>
  <cp:lastModifiedBy>Hussain, Salik</cp:lastModifiedBy>
  <cp:revision>125</cp:revision>
  <dcterms:created xsi:type="dcterms:W3CDTF">2020-11-10T18:14:55Z</dcterms:created>
  <dcterms:modified xsi:type="dcterms:W3CDTF">2021-08-02T15:47:37Z</dcterms:modified>
</cp:coreProperties>
</file>